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5" r:id="rId3"/>
    <p:sldId id="266" r:id="rId4"/>
    <p:sldId id="267" r:id="rId5"/>
    <p:sldId id="268" r:id="rId6"/>
    <p:sldId id="269" r:id="rId7"/>
    <p:sldId id="270" r:id="rId8"/>
  </p:sldIdLst>
  <p:sldSz cx="3044825" cy="21669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654AFB2-1672-4218-B1BE-C639FC50A9B1}" v="1" dt="2024-09-25T15:10:39.4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248" autoAdjust="0"/>
    <p:restoredTop sz="94660"/>
  </p:normalViewPr>
  <p:slideViewPr>
    <p:cSldViewPr snapToGrid="0">
      <p:cViewPr varScale="1">
        <p:scale>
          <a:sx n="313" d="100"/>
          <a:sy n="313" d="100"/>
        </p:scale>
        <p:origin x="2166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nda, Punyatoya" userId="c0a082b4-22b8-4715-b689-c3e101f73cbd" providerId="ADAL" clId="{B654AFB2-1672-4218-B1BE-C639FC50A9B1}"/>
    <pc:docChg chg="custSel modSld">
      <pc:chgData name="Panda, Punyatoya" userId="c0a082b4-22b8-4715-b689-c3e101f73cbd" providerId="ADAL" clId="{B654AFB2-1672-4218-B1BE-C639FC50A9B1}" dt="2024-09-25T15:10:53.661" v="6" actId="1076"/>
      <pc:docMkLst>
        <pc:docMk/>
      </pc:docMkLst>
      <pc:sldChg chg="addSp delSp modSp mod">
        <pc:chgData name="Panda, Punyatoya" userId="c0a082b4-22b8-4715-b689-c3e101f73cbd" providerId="ADAL" clId="{B654AFB2-1672-4218-B1BE-C639FC50A9B1}" dt="2024-09-25T15:10:53.661" v="6" actId="1076"/>
        <pc:sldMkLst>
          <pc:docMk/>
          <pc:sldMk cId="2605284934" sldId="268"/>
        </pc:sldMkLst>
        <pc:picChg chg="del">
          <ac:chgData name="Panda, Punyatoya" userId="c0a082b4-22b8-4715-b689-c3e101f73cbd" providerId="ADAL" clId="{B654AFB2-1672-4218-B1BE-C639FC50A9B1}" dt="2024-09-25T15:10:31.109" v="0" actId="478"/>
          <ac:picMkLst>
            <pc:docMk/>
            <pc:sldMk cId="2605284934" sldId="268"/>
            <ac:picMk id="3" creationId="{81A7BFBF-AF0C-0C4D-8A7E-C2369ACA6948}"/>
          </ac:picMkLst>
        </pc:picChg>
        <pc:picChg chg="add mod ord">
          <ac:chgData name="Panda, Punyatoya" userId="c0a082b4-22b8-4715-b689-c3e101f73cbd" providerId="ADAL" clId="{B654AFB2-1672-4218-B1BE-C639FC50A9B1}" dt="2024-09-25T15:10:53.661" v="6" actId="1076"/>
          <ac:picMkLst>
            <pc:docMk/>
            <pc:sldMk cId="2605284934" sldId="268"/>
            <ac:picMk id="5" creationId="{4684BECA-CDA3-8D4A-C26C-642DACB1CE3C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8362" y="354636"/>
            <a:ext cx="2588101" cy="754415"/>
          </a:xfrm>
        </p:spPr>
        <p:txBody>
          <a:bodyPr anchor="b"/>
          <a:lstStyle>
            <a:lvl1pPr algn="ctr">
              <a:defRPr sz="18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0603" y="1138144"/>
            <a:ext cx="2283619" cy="523175"/>
          </a:xfrm>
        </p:spPr>
        <p:txBody>
          <a:bodyPr/>
          <a:lstStyle>
            <a:lvl1pPr marL="0" indent="0" algn="ctr">
              <a:buNone/>
              <a:defRPr sz="758"/>
            </a:lvl1pPr>
            <a:lvl2pPr marL="144475" indent="0" algn="ctr">
              <a:buNone/>
              <a:defRPr sz="632"/>
            </a:lvl2pPr>
            <a:lvl3pPr marL="288950" indent="0" algn="ctr">
              <a:buNone/>
              <a:defRPr sz="569"/>
            </a:lvl3pPr>
            <a:lvl4pPr marL="433426" indent="0" algn="ctr">
              <a:buNone/>
              <a:defRPr sz="506"/>
            </a:lvl4pPr>
            <a:lvl5pPr marL="577901" indent="0" algn="ctr">
              <a:buNone/>
              <a:defRPr sz="506"/>
            </a:lvl5pPr>
            <a:lvl6pPr marL="722376" indent="0" algn="ctr">
              <a:buNone/>
              <a:defRPr sz="506"/>
            </a:lvl6pPr>
            <a:lvl7pPr marL="866851" indent="0" algn="ctr">
              <a:buNone/>
              <a:defRPr sz="506"/>
            </a:lvl7pPr>
            <a:lvl8pPr marL="1011326" indent="0" algn="ctr">
              <a:buNone/>
              <a:defRPr sz="506"/>
            </a:lvl8pPr>
            <a:lvl9pPr marL="1155802" indent="0" algn="ctr">
              <a:buNone/>
              <a:defRPr sz="50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494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594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78953" y="115369"/>
            <a:ext cx="656540" cy="183638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9332" y="115369"/>
            <a:ext cx="1931561" cy="183638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830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862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7746" y="540230"/>
            <a:ext cx="2626162" cy="901386"/>
          </a:xfrm>
        </p:spPr>
        <p:txBody>
          <a:bodyPr anchor="b"/>
          <a:lstStyle>
            <a:lvl1pPr>
              <a:defRPr sz="18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7746" y="1450143"/>
            <a:ext cx="2626162" cy="474018"/>
          </a:xfrm>
        </p:spPr>
        <p:txBody>
          <a:bodyPr/>
          <a:lstStyle>
            <a:lvl1pPr marL="0" indent="0">
              <a:buNone/>
              <a:defRPr sz="758">
                <a:solidFill>
                  <a:schemeClr val="tx1">
                    <a:tint val="82000"/>
                  </a:schemeClr>
                </a:solidFill>
              </a:defRPr>
            </a:lvl1pPr>
            <a:lvl2pPr marL="144475" indent="0">
              <a:buNone/>
              <a:defRPr sz="632">
                <a:solidFill>
                  <a:schemeClr val="tx1">
                    <a:tint val="82000"/>
                  </a:schemeClr>
                </a:solidFill>
              </a:defRPr>
            </a:lvl2pPr>
            <a:lvl3pPr marL="288950" indent="0">
              <a:buNone/>
              <a:defRPr sz="569">
                <a:solidFill>
                  <a:schemeClr val="tx1">
                    <a:tint val="82000"/>
                  </a:schemeClr>
                </a:solidFill>
              </a:defRPr>
            </a:lvl3pPr>
            <a:lvl4pPr marL="433426" indent="0">
              <a:buNone/>
              <a:defRPr sz="506">
                <a:solidFill>
                  <a:schemeClr val="tx1">
                    <a:tint val="82000"/>
                  </a:schemeClr>
                </a:solidFill>
              </a:defRPr>
            </a:lvl4pPr>
            <a:lvl5pPr marL="577901" indent="0">
              <a:buNone/>
              <a:defRPr sz="506">
                <a:solidFill>
                  <a:schemeClr val="tx1">
                    <a:tint val="82000"/>
                  </a:schemeClr>
                </a:solidFill>
              </a:defRPr>
            </a:lvl5pPr>
            <a:lvl6pPr marL="722376" indent="0">
              <a:buNone/>
              <a:defRPr sz="506">
                <a:solidFill>
                  <a:schemeClr val="tx1">
                    <a:tint val="82000"/>
                  </a:schemeClr>
                </a:solidFill>
              </a:defRPr>
            </a:lvl6pPr>
            <a:lvl7pPr marL="866851" indent="0">
              <a:buNone/>
              <a:defRPr sz="506">
                <a:solidFill>
                  <a:schemeClr val="tx1">
                    <a:tint val="82000"/>
                  </a:schemeClr>
                </a:solidFill>
              </a:defRPr>
            </a:lvl7pPr>
            <a:lvl8pPr marL="1011326" indent="0">
              <a:buNone/>
              <a:defRPr sz="506">
                <a:solidFill>
                  <a:schemeClr val="tx1">
                    <a:tint val="82000"/>
                  </a:schemeClr>
                </a:solidFill>
              </a:defRPr>
            </a:lvl8pPr>
            <a:lvl9pPr marL="1155802" indent="0">
              <a:buNone/>
              <a:defRPr sz="50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939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9332" y="576847"/>
            <a:ext cx="1294051" cy="13749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41442" y="576847"/>
            <a:ext cx="1294051" cy="13749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047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9728" y="115370"/>
            <a:ext cx="2626162" cy="41884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9729" y="531201"/>
            <a:ext cx="1288103" cy="260333"/>
          </a:xfrm>
        </p:spPr>
        <p:txBody>
          <a:bodyPr anchor="b"/>
          <a:lstStyle>
            <a:lvl1pPr marL="0" indent="0">
              <a:buNone/>
              <a:defRPr sz="758" b="1"/>
            </a:lvl1pPr>
            <a:lvl2pPr marL="144475" indent="0">
              <a:buNone/>
              <a:defRPr sz="632" b="1"/>
            </a:lvl2pPr>
            <a:lvl3pPr marL="288950" indent="0">
              <a:buNone/>
              <a:defRPr sz="569" b="1"/>
            </a:lvl3pPr>
            <a:lvl4pPr marL="433426" indent="0">
              <a:buNone/>
              <a:defRPr sz="506" b="1"/>
            </a:lvl4pPr>
            <a:lvl5pPr marL="577901" indent="0">
              <a:buNone/>
              <a:defRPr sz="506" b="1"/>
            </a:lvl5pPr>
            <a:lvl6pPr marL="722376" indent="0">
              <a:buNone/>
              <a:defRPr sz="506" b="1"/>
            </a:lvl6pPr>
            <a:lvl7pPr marL="866851" indent="0">
              <a:buNone/>
              <a:defRPr sz="506" b="1"/>
            </a:lvl7pPr>
            <a:lvl8pPr marL="1011326" indent="0">
              <a:buNone/>
              <a:defRPr sz="506" b="1"/>
            </a:lvl8pPr>
            <a:lvl9pPr marL="1155802" indent="0">
              <a:buNone/>
              <a:defRPr sz="50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9729" y="791534"/>
            <a:ext cx="1288103" cy="116422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41443" y="531201"/>
            <a:ext cx="1294447" cy="260333"/>
          </a:xfrm>
        </p:spPr>
        <p:txBody>
          <a:bodyPr anchor="b"/>
          <a:lstStyle>
            <a:lvl1pPr marL="0" indent="0">
              <a:buNone/>
              <a:defRPr sz="758" b="1"/>
            </a:lvl1pPr>
            <a:lvl2pPr marL="144475" indent="0">
              <a:buNone/>
              <a:defRPr sz="632" b="1"/>
            </a:lvl2pPr>
            <a:lvl3pPr marL="288950" indent="0">
              <a:buNone/>
              <a:defRPr sz="569" b="1"/>
            </a:lvl3pPr>
            <a:lvl4pPr marL="433426" indent="0">
              <a:buNone/>
              <a:defRPr sz="506" b="1"/>
            </a:lvl4pPr>
            <a:lvl5pPr marL="577901" indent="0">
              <a:buNone/>
              <a:defRPr sz="506" b="1"/>
            </a:lvl5pPr>
            <a:lvl6pPr marL="722376" indent="0">
              <a:buNone/>
              <a:defRPr sz="506" b="1"/>
            </a:lvl6pPr>
            <a:lvl7pPr marL="866851" indent="0">
              <a:buNone/>
              <a:defRPr sz="506" b="1"/>
            </a:lvl7pPr>
            <a:lvl8pPr marL="1011326" indent="0">
              <a:buNone/>
              <a:defRPr sz="506" b="1"/>
            </a:lvl8pPr>
            <a:lvl9pPr marL="1155802" indent="0">
              <a:buNone/>
              <a:defRPr sz="50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41443" y="791534"/>
            <a:ext cx="1294447" cy="116422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737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658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53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9728" y="144462"/>
            <a:ext cx="982035" cy="505619"/>
          </a:xfrm>
        </p:spPr>
        <p:txBody>
          <a:bodyPr anchor="b"/>
          <a:lstStyle>
            <a:lvl1pPr>
              <a:defRPr sz="10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94447" y="312000"/>
            <a:ext cx="1541443" cy="1539930"/>
          </a:xfrm>
        </p:spPr>
        <p:txBody>
          <a:bodyPr/>
          <a:lstStyle>
            <a:lvl1pPr>
              <a:defRPr sz="1011"/>
            </a:lvl1pPr>
            <a:lvl2pPr>
              <a:defRPr sz="885"/>
            </a:lvl2pPr>
            <a:lvl3pPr>
              <a:defRPr sz="758"/>
            </a:lvl3pPr>
            <a:lvl4pPr>
              <a:defRPr sz="632"/>
            </a:lvl4pPr>
            <a:lvl5pPr>
              <a:defRPr sz="632"/>
            </a:lvl5pPr>
            <a:lvl6pPr>
              <a:defRPr sz="632"/>
            </a:lvl6pPr>
            <a:lvl7pPr>
              <a:defRPr sz="632"/>
            </a:lvl7pPr>
            <a:lvl8pPr>
              <a:defRPr sz="632"/>
            </a:lvl8pPr>
            <a:lvl9pPr>
              <a:defRPr sz="63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9728" y="650082"/>
            <a:ext cx="982035" cy="1204356"/>
          </a:xfrm>
        </p:spPr>
        <p:txBody>
          <a:bodyPr/>
          <a:lstStyle>
            <a:lvl1pPr marL="0" indent="0">
              <a:buNone/>
              <a:defRPr sz="506"/>
            </a:lvl1pPr>
            <a:lvl2pPr marL="144475" indent="0">
              <a:buNone/>
              <a:defRPr sz="442"/>
            </a:lvl2pPr>
            <a:lvl3pPr marL="288950" indent="0">
              <a:buNone/>
              <a:defRPr sz="379"/>
            </a:lvl3pPr>
            <a:lvl4pPr marL="433426" indent="0">
              <a:buNone/>
              <a:defRPr sz="316"/>
            </a:lvl4pPr>
            <a:lvl5pPr marL="577901" indent="0">
              <a:buNone/>
              <a:defRPr sz="316"/>
            </a:lvl5pPr>
            <a:lvl6pPr marL="722376" indent="0">
              <a:buNone/>
              <a:defRPr sz="316"/>
            </a:lvl6pPr>
            <a:lvl7pPr marL="866851" indent="0">
              <a:buNone/>
              <a:defRPr sz="316"/>
            </a:lvl7pPr>
            <a:lvl8pPr marL="1011326" indent="0">
              <a:buNone/>
              <a:defRPr sz="316"/>
            </a:lvl8pPr>
            <a:lvl9pPr marL="1155802" indent="0">
              <a:buNone/>
              <a:defRPr sz="31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724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9728" y="144462"/>
            <a:ext cx="982035" cy="505619"/>
          </a:xfrm>
        </p:spPr>
        <p:txBody>
          <a:bodyPr anchor="b"/>
          <a:lstStyle>
            <a:lvl1pPr>
              <a:defRPr sz="10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94447" y="312000"/>
            <a:ext cx="1541443" cy="1539930"/>
          </a:xfrm>
        </p:spPr>
        <p:txBody>
          <a:bodyPr anchor="t"/>
          <a:lstStyle>
            <a:lvl1pPr marL="0" indent="0">
              <a:buNone/>
              <a:defRPr sz="1011"/>
            </a:lvl1pPr>
            <a:lvl2pPr marL="144475" indent="0">
              <a:buNone/>
              <a:defRPr sz="885"/>
            </a:lvl2pPr>
            <a:lvl3pPr marL="288950" indent="0">
              <a:buNone/>
              <a:defRPr sz="758"/>
            </a:lvl3pPr>
            <a:lvl4pPr marL="433426" indent="0">
              <a:buNone/>
              <a:defRPr sz="632"/>
            </a:lvl4pPr>
            <a:lvl5pPr marL="577901" indent="0">
              <a:buNone/>
              <a:defRPr sz="632"/>
            </a:lvl5pPr>
            <a:lvl6pPr marL="722376" indent="0">
              <a:buNone/>
              <a:defRPr sz="632"/>
            </a:lvl6pPr>
            <a:lvl7pPr marL="866851" indent="0">
              <a:buNone/>
              <a:defRPr sz="632"/>
            </a:lvl7pPr>
            <a:lvl8pPr marL="1011326" indent="0">
              <a:buNone/>
              <a:defRPr sz="632"/>
            </a:lvl8pPr>
            <a:lvl9pPr marL="1155802" indent="0">
              <a:buNone/>
              <a:defRPr sz="63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9728" y="650082"/>
            <a:ext cx="982035" cy="1204356"/>
          </a:xfrm>
        </p:spPr>
        <p:txBody>
          <a:bodyPr/>
          <a:lstStyle>
            <a:lvl1pPr marL="0" indent="0">
              <a:buNone/>
              <a:defRPr sz="506"/>
            </a:lvl1pPr>
            <a:lvl2pPr marL="144475" indent="0">
              <a:buNone/>
              <a:defRPr sz="442"/>
            </a:lvl2pPr>
            <a:lvl3pPr marL="288950" indent="0">
              <a:buNone/>
              <a:defRPr sz="379"/>
            </a:lvl3pPr>
            <a:lvl4pPr marL="433426" indent="0">
              <a:buNone/>
              <a:defRPr sz="316"/>
            </a:lvl4pPr>
            <a:lvl5pPr marL="577901" indent="0">
              <a:buNone/>
              <a:defRPr sz="316"/>
            </a:lvl5pPr>
            <a:lvl6pPr marL="722376" indent="0">
              <a:buNone/>
              <a:defRPr sz="316"/>
            </a:lvl6pPr>
            <a:lvl7pPr marL="866851" indent="0">
              <a:buNone/>
              <a:defRPr sz="316"/>
            </a:lvl7pPr>
            <a:lvl8pPr marL="1011326" indent="0">
              <a:buNone/>
              <a:defRPr sz="316"/>
            </a:lvl8pPr>
            <a:lvl9pPr marL="1155802" indent="0">
              <a:buNone/>
              <a:defRPr sz="31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843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9332" y="115370"/>
            <a:ext cx="2626162" cy="418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9332" y="576847"/>
            <a:ext cx="2626162" cy="13749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9332" y="2008431"/>
            <a:ext cx="685086" cy="115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216F01-E0E6-4C9B-8F9D-B8433EF75520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8599" y="2008431"/>
            <a:ext cx="1027628" cy="115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50407" y="2008431"/>
            <a:ext cx="685086" cy="115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6F9FDA-76A7-4397-BC09-59E6E63DD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977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88950" rtl="0" eaLnBrk="1" latinLnBrk="0" hangingPunct="1">
        <a:lnSpc>
          <a:spcPct val="90000"/>
        </a:lnSpc>
        <a:spcBef>
          <a:spcPct val="0"/>
        </a:spcBef>
        <a:buNone/>
        <a:defRPr sz="13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2238" indent="-72238" algn="l" defTabSz="288950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sz="885" kern="1200">
          <a:solidFill>
            <a:schemeClr val="tx1"/>
          </a:solidFill>
          <a:latin typeface="+mn-lt"/>
          <a:ea typeface="+mn-ea"/>
          <a:cs typeface="+mn-cs"/>
        </a:defRPr>
      </a:lvl1pPr>
      <a:lvl2pPr marL="216713" indent="-72238" algn="l" defTabSz="288950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758" kern="1200">
          <a:solidFill>
            <a:schemeClr val="tx1"/>
          </a:solidFill>
          <a:latin typeface="+mn-lt"/>
          <a:ea typeface="+mn-ea"/>
          <a:cs typeface="+mn-cs"/>
        </a:defRPr>
      </a:lvl2pPr>
      <a:lvl3pPr marL="361188" indent="-72238" algn="l" defTabSz="288950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632" kern="1200">
          <a:solidFill>
            <a:schemeClr val="tx1"/>
          </a:solidFill>
          <a:latin typeface="+mn-lt"/>
          <a:ea typeface="+mn-ea"/>
          <a:cs typeface="+mn-cs"/>
        </a:defRPr>
      </a:lvl3pPr>
      <a:lvl4pPr marL="505663" indent="-72238" algn="l" defTabSz="288950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9" kern="1200">
          <a:solidFill>
            <a:schemeClr val="tx1"/>
          </a:solidFill>
          <a:latin typeface="+mn-lt"/>
          <a:ea typeface="+mn-ea"/>
          <a:cs typeface="+mn-cs"/>
        </a:defRPr>
      </a:lvl4pPr>
      <a:lvl5pPr marL="650138" indent="-72238" algn="l" defTabSz="288950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9" kern="1200">
          <a:solidFill>
            <a:schemeClr val="tx1"/>
          </a:solidFill>
          <a:latin typeface="+mn-lt"/>
          <a:ea typeface="+mn-ea"/>
          <a:cs typeface="+mn-cs"/>
        </a:defRPr>
      </a:lvl5pPr>
      <a:lvl6pPr marL="794614" indent="-72238" algn="l" defTabSz="288950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9" kern="1200">
          <a:solidFill>
            <a:schemeClr val="tx1"/>
          </a:solidFill>
          <a:latin typeface="+mn-lt"/>
          <a:ea typeface="+mn-ea"/>
          <a:cs typeface="+mn-cs"/>
        </a:defRPr>
      </a:lvl6pPr>
      <a:lvl7pPr marL="939089" indent="-72238" algn="l" defTabSz="288950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9" kern="1200">
          <a:solidFill>
            <a:schemeClr val="tx1"/>
          </a:solidFill>
          <a:latin typeface="+mn-lt"/>
          <a:ea typeface="+mn-ea"/>
          <a:cs typeface="+mn-cs"/>
        </a:defRPr>
      </a:lvl7pPr>
      <a:lvl8pPr marL="1083564" indent="-72238" algn="l" defTabSz="288950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9" kern="1200">
          <a:solidFill>
            <a:schemeClr val="tx1"/>
          </a:solidFill>
          <a:latin typeface="+mn-lt"/>
          <a:ea typeface="+mn-ea"/>
          <a:cs typeface="+mn-cs"/>
        </a:defRPr>
      </a:lvl8pPr>
      <a:lvl9pPr marL="1228039" indent="-72238" algn="l" defTabSz="288950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1pPr>
      <a:lvl2pPr marL="144475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2pPr>
      <a:lvl3pPr marL="288950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3pPr>
      <a:lvl4pPr marL="433426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4pPr>
      <a:lvl5pPr marL="577901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5pPr>
      <a:lvl6pPr marL="722376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6pPr>
      <a:lvl7pPr marL="866851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7pPr>
      <a:lvl8pPr marL="1011326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8pPr>
      <a:lvl9pPr marL="1155802" algn="l" defTabSz="288950" rtl="0" eaLnBrk="1" latinLnBrk="0" hangingPunct="1">
        <a:defRPr sz="5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graphs showing different colored dots&#10;&#10;Description automatically generated">
            <a:extLst>
              <a:ext uri="{FF2B5EF4-FFF2-40B4-BE49-F238E27FC236}">
                <a16:creationId xmlns:a16="http://schemas.microsoft.com/office/drawing/2014/main" id="{A517DB2E-7F1E-33C1-F086-CA971DB56E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8" y="0"/>
            <a:ext cx="3033508" cy="216693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5252151-822D-083C-557F-5FE197980757}"/>
              </a:ext>
            </a:extLst>
          </p:cNvPr>
          <p:cNvSpPr txBox="1"/>
          <p:nvPr/>
        </p:nvSpPr>
        <p:spPr>
          <a:xfrm>
            <a:off x="74445" y="0"/>
            <a:ext cx="1059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477087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ollage of diagrams with different colored dots&#10;&#10;Description automatically generated">
            <a:extLst>
              <a:ext uri="{FF2B5EF4-FFF2-40B4-BE49-F238E27FC236}">
                <a16:creationId xmlns:a16="http://schemas.microsoft.com/office/drawing/2014/main" id="{AE31A366-929B-F928-65DF-22022BCC55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57" y="98291"/>
            <a:ext cx="2895910" cy="206864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B2C0831-84B5-6722-B941-9CD3D759F223}"/>
              </a:ext>
            </a:extLst>
          </p:cNvPr>
          <p:cNvSpPr txBox="1"/>
          <p:nvPr/>
        </p:nvSpPr>
        <p:spPr>
          <a:xfrm>
            <a:off x="-70104" y="-51816"/>
            <a:ext cx="1059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7293201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8031E406-0570-C05C-1F40-31EFABB4646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656" b="16589"/>
          <a:stretch/>
        </p:blipFill>
        <p:spPr>
          <a:xfrm>
            <a:off x="130626" y="237744"/>
            <a:ext cx="2740590" cy="18074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FC227AA-5E6F-B33B-6F1B-75C4EFD9EA04}"/>
              </a:ext>
            </a:extLst>
          </p:cNvPr>
          <p:cNvSpPr txBox="1"/>
          <p:nvPr/>
        </p:nvSpPr>
        <p:spPr>
          <a:xfrm>
            <a:off x="-64008" y="-33528"/>
            <a:ext cx="1059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20661839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8ED06961-6872-F11A-F41F-09DBFAAB8D2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186" b="11947"/>
          <a:stretch/>
        </p:blipFill>
        <p:spPr>
          <a:xfrm>
            <a:off x="5658" y="152400"/>
            <a:ext cx="3039167" cy="190804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7B306C5-70CE-930F-43CD-B8E72653705F}"/>
              </a:ext>
            </a:extLst>
          </p:cNvPr>
          <p:cNvSpPr txBox="1"/>
          <p:nvPr/>
        </p:nvSpPr>
        <p:spPr>
          <a:xfrm>
            <a:off x="-60960" y="-32266"/>
            <a:ext cx="1059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21145707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 screen&#10;&#10;Description automatically generated with medium confidence">
            <a:extLst>
              <a:ext uri="{FF2B5EF4-FFF2-40B4-BE49-F238E27FC236}">
                <a16:creationId xmlns:a16="http://schemas.microsoft.com/office/drawing/2014/main" id="{4684BECA-CDA3-8D4A-C26C-642DACB1CE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0873"/>
            <a:ext cx="2920294" cy="208606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4D8AC32-9099-844C-EB0B-44746F208C11}"/>
              </a:ext>
            </a:extLst>
          </p:cNvPr>
          <p:cNvSpPr txBox="1"/>
          <p:nvPr/>
        </p:nvSpPr>
        <p:spPr>
          <a:xfrm>
            <a:off x="-67056" y="-40517"/>
            <a:ext cx="1059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26052849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hart&#10;&#10;Description automatically generated">
            <a:extLst>
              <a:ext uri="{FF2B5EF4-FFF2-40B4-BE49-F238E27FC236}">
                <a16:creationId xmlns:a16="http://schemas.microsoft.com/office/drawing/2014/main" id="{B69C1A44-A3F1-A8D4-B901-6B2335CD79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8" y="0"/>
            <a:ext cx="3033508" cy="216693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9D77A8D-C145-ABE1-7B9B-2E562D0E60B4}"/>
              </a:ext>
            </a:extLst>
          </p:cNvPr>
          <p:cNvSpPr txBox="1"/>
          <p:nvPr/>
        </p:nvSpPr>
        <p:spPr>
          <a:xfrm>
            <a:off x="-57912" y="-36576"/>
            <a:ext cx="1059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33071457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diagram&#10;&#10;Description automatically generated">
            <a:extLst>
              <a:ext uri="{FF2B5EF4-FFF2-40B4-BE49-F238E27FC236}">
                <a16:creationId xmlns:a16="http://schemas.microsoft.com/office/drawing/2014/main" id="{DB7F9EE5-599F-B0FE-971E-3B381C15AA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89" y="83050"/>
            <a:ext cx="2917246" cy="208388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17A1BB1-0439-0444-B294-14694C2ED0CF}"/>
              </a:ext>
            </a:extLst>
          </p:cNvPr>
          <p:cNvSpPr txBox="1"/>
          <p:nvPr/>
        </p:nvSpPr>
        <p:spPr>
          <a:xfrm>
            <a:off x="-64008" y="-42672"/>
            <a:ext cx="1059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</p:spTree>
    <p:extLst>
      <p:ext uri="{BB962C8B-B14F-4D97-AF65-F5344CB8AC3E}">
        <p14:creationId xmlns:p14="http://schemas.microsoft.com/office/powerpoint/2010/main" val="4142495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</TotalTime>
  <Words>21</Words>
  <Application>Microsoft Office PowerPoint</Application>
  <PresentationFormat>Custom</PresentationFormat>
  <Paragraphs>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unyatoya Panda</dc:creator>
  <cp:lastModifiedBy>Panda, Punyatoya</cp:lastModifiedBy>
  <cp:revision>2</cp:revision>
  <dcterms:created xsi:type="dcterms:W3CDTF">2024-07-30T19:10:52Z</dcterms:created>
  <dcterms:modified xsi:type="dcterms:W3CDTF">2024-09-25T15:10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044bd30-2ed7-4c9d-9d12-46200872a97b_Enabled">
    <vt:lpwstr>true</vt:lpwstr>
  </property>
  <property fmtid="{D5CDD505-2E9C-101B-9397-08002B2CF9AE}" pid="3" name="MSIP_Label_4044bd30-2ed7-4c9d-9d12-46200872a97b_SetDate">
    <vt:lpwstr>2024-07-30T19:13:14Z</vt:lpwstr>
  </property>
  <property fmtid="{D5CDD505-2E9C-101B-9397-08002B2CF9AE}" pid="4" name="MSIP_Label_4044bd30-2ed7-4c9d-9d12-46200872a97b_Method">
    <vt:lpwstr>Standard</vt:lpwstr>
  </property>
  <property fmtid="{D5CDD505-2E9C-101B-9397-08002B2CF9AE}" pid="5" name="MSIP_Label_4044bd30-2ed7-4c9d-9d12-46200872a97b_Name">
    <vt:lpwstr>defa4170-0d19-0005-0004-bc88714345d2</vt:lpwstr>
  </property>
  <property fmtid="{D5CDD505-2E9C-101B-9397-08002B2CF9AE}" pid="6" name="MSIP_Label_4044bd30-2ed7-4c9d-9d12-46200872a97b_SiteId">
    <vt:lpwstr>4130bd39-7c53-419c-b1e5-8758d6d63f21</vt:lpwstr>
  </property>
  <property fmtid="{D5CDD505-2E9C-101B-9397-08002B2CF9AE}" pid="7" name="MSIP_Label_4044bd30-2ed7-4c9d-9d12-46200872a97b_ActionId">
    <vt:lpwstr>230259ec-e44e-407a-99bf-e4aa0d787d82</vt:lpwstr>
  </property>
  <property fmtid="{D5CDD505-2E9C-101B-9397-08002B2CF9AE}" pid="8" name="MSIP_Label_4044bd30-2ed7-4c9d-9d12-46200872a97b_ContentBits">
    <vt:lpwstr>0</vt:lpwstr>
  </property>
</Properties>
</file>